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E0028"/>
    <a:srgbClr val="004B9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47"/>
    <p:restoredTop sz="94663"/>
  </p:normalViewPr>
  <p:slideViewPr>
    <p:cSldViewPr>
      <p:cViewPr>
        <p:scale>
          <a:sx n="87" d="100"/>
          <a:sy n="87" d="100"/>
        </p:scale>
        <p:origin x="-2316" y="-5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FA4A57A-4AC0-4633-9F18-87DC97419758}" type="datetimeFigureOut">
              <a:rPr lang="de-DE" smtClean="0"/>
              <a:t>29.09.2020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F14BFB5-74A8-4D28-8787-73EE66589B7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445717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14BFB5-74A8-4D28-8787-73EE66589B7D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146366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9.09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9.09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/>
              <a:t>Titel durch Klicken hinzufüg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9.09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9.09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9.09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9.09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9.09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9.09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9.09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9.09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9.09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50D42-C9CD-4801-B293-61D1F53EC57E}" type="datetimeFigureOut">
              <a:rPr lang="de-DE" smtClean="0"/>
              <a:t>29.09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7" name="Gekrümmte Verbindung 16"/>
          <p:cNvCxnSpPr>
            <a:cxnSpLocks/>
            <a:stCxn id="13" idx="3"/>
            <a:endCxn id="12" idx="0"/>
          </p:cNvCxnSpPr>
          <p:nvPr/>
        </p:nvCxnSpPr>
        <p:spPr>
          <a:xfrm>
            <a:off x="1841797" y="950826"/>
            <a:ext cx="4378182" cy="505703"/>
          </a:xfrm>
          <a:prstGeom prst="curvedConnector3">
            <a:avLst>
              <a:gd name="adj1" fmla="val 111550"/>
            </a:avLst>
          </a:prstGeom>
          <a:ln w="25400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Ellipse 3"/>
          <p:cNvSpPr/>
          <p:nvPr/>
        </p:nvSpPr>
        <p:spPr>
          <a:xfrm>
            <a:off x="3347864" y="620688"/>
            <a:ext cx="2952328" cy="3672408"/>
          </a:xfrm>
          <a:prstGeom prst="ellipse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Abgerundetes Rechteck 5"/>
          <p:cNvSpPr/>
          <p:nvPr/>
        </p:nvSpPr>
        <p:spPr>
          <a:xfrm rot="20043389">
            <a:off x="5298505" y="2481167"/>
            <a:ext cx="895883" cy="1019246"/>
          </a:xfrm>
          <a:prstGeom prst="round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Abgerundetes Rechteck 6"/>
          <p:cNvSpPr/>
          <p:nvPr/>
        </p:nvSpPr>
        <p:spPr>
          <a:xfrm>
            <a:off x="4499992" y="2674267"/>
            <a:ext cx="1728817" cy="1278716"/>
          </a:xfrm>
          <a:prstGeom prst="round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Abgerundetes Rechteck 7"/>
          <p:cNvSpPr/>
          <p:nvPr/>
        </p:nvSpPr>
        <p:spPr>
          <a:xfrm>
            <a:off x="4067944" y="2708920"/>
            <a:ext cx="1440160" cy="2343506"/>
          </a:xfrm>
          <a:prstGeom prst="round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Abgerundetes Rechteck 8"/>
          <p:cNvSpPr/>
          <p:nvPr/>
        </p:nvSpPr>
        <p:spPr>
          <a:xfrm rot="19912454">
            <a:off x="5668280" y="1976276"/>
            <a:ext cx="733873" cy="989980"/>
          </a:xfrm>
          <a:prstGeom prst="round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Abgerundetes Rechteck 9"/>
          <p:cNvSpPr/>
          <p:nvPr/>
        </p:nvSpPr>
        <p:spPr>
          <a:xfrm rot="13200648">
            <a:off x="5636737" y="3060773"/>
            <a:ext cx="615514" cy="505703"/>
          </a:xfrm>
          <a:prstGeom prst="round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Abgerundetes Rechteck 10"/>
          <p:cNvSpPr/>
          <p:nvPr/>
        </p:nvSpPr>
        <p:spPr>
          <a:xfrm rot="16779695">
            <a:off x="2933819" y="2078848"/>
            <a:ext cx="648072" cy="108013"/>
          </a:xfrm>
          <a:prstGeom prst="roundRect">
            <a:avLst/>
          </a:prstGeom>
          <a:solidFill>
            <a:srgbClr val="BE002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Abgerundetes Rechteck 11"/>
          <p:cNvSpPr/>
          <p:nvPr/>
        </p:nvSpPr>
        <p:spPr>
          <a:xfrm rot="3621003">
            <a:off x="5849008" y="1429239"/>
            <a:ext cx="648072" cy="108013"/>
          </a:xfrm>
          <a:prstGeom prst="roundRect">
            <a:avLst/>
          </a:prstGeom>
          <a:solidFill>
            <a:srgbClr val="004B9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echteck 12"/>
          <p:cNvSpPr/>
          <p:nvPr/>
        </p:nvSpPr>
        <p:spPr>
          <a:xfrm>
            <a:off x="755576" y="523645"/>
            <a:ext cx="1086221" cy="854362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tDCS</a:t>
            </a:r>
          </a:p>
        </p:txBody>
      </p:sp>
      <p:cxnSp>
        <p:nvCxnSpPr>
          <p:cNvPr id="16" name="Gekrümmte Verbindung 15"/>
          <p:cNvCxnSpPr>
            <a:cxnSpLocks/>
            <a:stCxn id="13" idx="3"/>
            <a:endCxn id="11" idx="0"/>
          </p:cNvCxnSpPr>
          <p:nvPr/>
        </p:nvCxnSpPr>
        <p:spPr>
          <a:xfrm>
            <a:off x="1841797" y="950826"/>
            <a:ext cx="1362818" cy="1172965"/>
          </a:xfrm>
          <a:prstGeom prst="curvedConnector3">
            <a:avLst>
              <a:gd name="adj1" fmla="val 50000"/>
            </a:avLst>
          </a:prstGeom>
          <a:ln w="25400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Rechteck 19"/>
          <p:cNvSpPr/>
          <p:nvPr/>
        </p:nvSpPr>
        <p:spPr>
          <a:xfrm>
            <a:off x="7596336" y="1424999"/>
            <a:ext cx="1408751" cy="1351773"/>
          </a:xfrm>
          <a:prstGeom prst="rect">
            <a:avLst/>
          </a:prstGeom>
          <a:pattFill prst="lgCheck">
            <a:fgClr>
              <a:schemeClr val="tx1"/>
            </a:fgClr>
            <a:bgClr>
              <a:schemeClr val="bg1"/>
            </a:bgClr>
          </a:patt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Pfeil nach unten 20"/>
          <p:cNvSpPr/>
          <p:nvPr/>
        </p:nvSpPr>
        <p:spPr>
          <a:xfrm rot="5400000">
            <a:off x="6871842" y="1617372"/>
            <a:ext cx="214224" cy="946731"/>
          </a:xfrm>
          <a:prstGeom prst="downArrow">
            <a:avLst/>
          </a:prstGeom>
          <a:noFill/>
          <a:ln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4" name="Gruppieren 23"/>
          <p:cNvGrpSpPr/>
          <p:nvPr/>
        </p:nvGrpSpPr>
        <p:grpSpPr>
          <a:xfrm>
            <a:off x="5755037" y="4175538"/>
            <a:ext cx="3281459" cy="2492203"/>
            <a:chOff x="29733" y="162750"/>
            <a:chExt cx="4666060" cy="3341262"/>
          </a:xfrm>
        </p:grpSpPr>
        <p:pic>
          <p:nvPicPr>
            <p:cNvPr id="25" name="Picture 2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39401" y="162750"/>
              <a:ext cx="4556392" cy="32206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6" name="Rechteck 25"/>
            <p:cNvSpPr/>
            <p:nvPr/>
          </p:nvSpPr>
          <p:spPr>
            <a:xfrm rot="16200000">
              <a:off x="-905358" y="1506974"/>
              <a:ext cx="2264059" cy="39387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>
              <a:spAutoFit/>
            </a:bodyPr>
            <a:lstStyle/>
            <a:p>
              <a:pPr algn="ctr">
                <a:defRPr sz="1200" b="0" i="0" u="none" strike="noStrike" kern="1200" baseline="0">
                  <a:solidFill>
                    <a:prstClr val="black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r>
                <a:rPr lang="de-DE" b="1" dirty="0">
                  <a:latin typeface="Arial" panose="020B0604020202020204" pitchFamily="34" charset="0"/>
                  <a:cs typeface="Arial" panose="020B0604020202020204" pitchFamily="34" charset="0"/>
                </a:rPr>
                <a:t>VEP </a:t>
              </a:r>
              <a:r>
                <a:rPr lang="de-DE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amplitude</a:t>
              </a:r>
              <a:r>
                <a:rPr lang="de-DE" b="1" dirty="0">
                  <a:latin typeface="Arial" panose="020B0604020202020204" pitchFamily="34" charset="0"/>
                  <a:cs typeface="Arial" panose="020B0604020202020204" pitchFamily="34" charset="0"/>
                </a:rPr>
                <a:t>  [</a:t>
              </a:r>
              <a:r>
                <a:rPr lang="de-DE" b="1" dirty="0">
                  <a:latin typeface="Symbol" panose="05050102010706020507" pitchFamily="18" charset="2"/>
                  <a:cs typeface="Arial" panose="020B0604020202020204" pitchFamily="34" charset="0"/>
                </a:rPr>
                <a:t>m</a:t>
              </a:r>
              <a:r>
                <a:rPr lang="de-DE" b="1" dirty="0">
                  <a:latin typeface="Arial" panose="020B0604020202020204" pitchFamily="34" charset="0"/>
                  <a:cs typeface="Arial" panose="020B0604020202020204" pitchFamily="34" charset="0"/>
                </a:rPr>
                <a:t>V]</a:t>
              </a:r>
            </a:p>
          </p:txBody>
        </p:sp>
        <p:sp>
          <p:nvSpPr>
            <p:cNvPr id="27" name="Textfeld 26"/>
            <p:cNvSpPr txBox="1"/>
            <p:nvPr/>
          </p:nvSpPr>
          <p:spPr>
            <a:xfrm>
              <a:off x="2112663" y="3132643"/>
              <a:ext cx="1291226" cy="37136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ime </a:t>
              </a:r>
              <a:r>
                <a:rPr lang="de-DE" sz="1200" b="1">
                  <a:latin typeface="Arial" panose="020B0604020202020204" pitchFamily="34" charset="0"/>
                  <a:cs typeface="Arial" panose="020B0604020202020204" pitchFamily="34" charset="0"/>
                </a:rPr>
                <a:t>[</a:t>
              </a:r>
              <a:r>
                <a:rPr lang="de-DE" sz="1200" b="1" smtClean="0">
                  <a:latin typeface="Arial" panose="020B0604020202020204" pitchFamily="34" charset="0"/>
                  <a:cs typeface="Arial" panose="020B0604020202020204" pitchFamily="34" charset="0"/>
                </a:rPr>
                <a:t>ms]</a:t>
              </a:r>
              <a:endParaRPr lang="de-D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2" name="Freihandform 31"/>
          <p:cNvSpPr/>
          <p:nvPr/>
        </p:nvSpPr>
        <p:spPr>
          <a:xfrm>
            <a:off x="3466315" y="1365855"/>
            <a:ext cx="1537733" cy="963042"/>
          </a:xfrm>
          <a:custGeom>
            <a:avLst/>
            <a:gdLst>
              <a:gd name="connsiteX0" fmla="*/ 0 w 2095130"/>
              <a:gd name="connsiteY0" fmla="*/ 704350 h 1462572"/>
              <a:gd name="connsiteX1" fmla="*/ 248574 w 2095130"/>
              <a:gd name="connsiteY1" fmla="*/ 704350 h 1462572"/>
              <a:gd name="connsiteX2" fmla="*/ 381739 w 2095130"/>
              <a:gd name="connsiteY2" fmla="*/ 1450075 h 1462572"/>
              <a:gd name="connsiteX3" fmla="*/ 506027 w 2095130"/>
              <a:gd name="connsiteY3" fmla="*/ 3014 h 1462572"/>
              <a:gd name="connsiteX4" fmla="*/ 710213 w 2095130"/>
              <a:gd name="connsiteY4" fmla="*/ 1050579 h 1462572"/>
              <a:gd name="connsiteX5" fmla="*/ 958788 w 2095130"/>
              <a:gd name="connsiteY5" fmla="*/ 340366 h 1462572"/>
              <a:gd name="connsiteX6" fmla="*/ 1171852 w 2095130"/>
              <a:gd name="connsiteY6" fmla="*/ 224956 h 1462572"/>
              <a:gd name="connsiteX7" fmla="*/ 1429304 w 2095130"/>
              <a:gd name="connsiteY7" fmla="*/ 935170 h 1462572"/>
              <a:gd name="connsiteX8" fmla="*/ 1633491 w 2095130"/>
              <a:gd name="connsiteY8" fmla="*/ 1006191 h 1462572"/>
              <a:gd name="connsiteX9" fmla="*/ 1819922 w 2095130"/>
              <a:gd name="connsiteY9" fmla="*/ 704350 h 1462572"/>
              <a:gd name="connsiteX10" fmla="*/ 2095130 w 2095130"/>
              <a:gd name="connsiteY10" fmla="*/ 704350 h 146257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</a:cxnLst>
            <a:rect l="l" t="t" r="r" b="b"/>
            <a:pathLst>
              <a:path w="2095130" h="1462572">
                <a:moveTo>
                  <a:pt x="0" y="704350"/>
                </a:moveTo>
                <a:cubicBezTo>
                  <a:pt x="92475" y="642206"/>
                  <a:pt x="184951" y="580062"/>
                  <a:pt x="248574" y="704350"/>
                </a:cubicBezTo>
                <a:cubicBezTo>
                  <a:pt x="312197" y="828638"/>
                  <a:pt x="338830" y="1566964"/>
                  <a:pt x="381739" y="1450075"/>
                </a:cubicBezTo>
                <a:cubicBezTo>
                  <a:pt x="424648" y="1333186"/>
                  <a:pt x="451281" y="69597"/>
                  <a:pt x="506027" y="3014"/>
                </a:cubicBezTo>
                <a:cubicBezTo>
                  <a:pt x="560773" y="-63569"/>
                  <a:pt x="634753" y="994354"/>
                  <a:pt x="710213" y="1050579"/>
                </a:cubicBezTo>
                <a:cubicBezTo>
                  <a:pt x="785673" y="1106804"/>
                  <a:pt x="881848" y="477970"/>
                  <a:pt x="958788" y="340366"/>
                </a:cubicBezTo>
                <a:cubicBezTo>
                  <a:pt x="1035728" y="202762"/>
                  <a:pt x="1093433" y="125822"/>
                  <a:pt x="1171852" y="224956"/>
                </a:cubicBezTo>
                <a:cubicBezTo>
                  <a:pt x="1250271" y="324090"/>
                  <a:pt x="1352364" y="804964"/>
                  <a:pt x="1429304" y="935170"/>
                </a:cubicBezTo>
                <a:cubicBezTo>
                  <a:pt x="1506244" y="1065376"/>
                  <a:pt x="1568388" y="1044661"/>
                  <a:pt x="1633491" y="1006191"/>
                </a:cubicBezTo>
                <a:cubicBezTo>
                  <a:pt x="1698594" y="967721"/>
                  <a:pt x="1742982" y="754657"/>
                  <a:pt x="1819922" y="704350"/>
                </a:cubicBezTo>
                <a:cubicBezTo>
                  <a:pt x="1896862" y="654043"/>
                  <a:pt x="2032986" y="645165"/>
                  <a:pt x="2095130" y="704350"/>
                </a:cubicBezTo>
              </a:path>
            </a:pathLst>
          </a:cu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Rechteck 32"/>
          <p:cNvSpPr/>
          <p:nvPr/>
        </p:nvSpPr>
        <p:spPr>
          <a:xfrm rot="16200000">
            <a:off x="-402215" y="5186825"/>
            <a:ext cx="1688732" cy="276999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pPr algn="ctr">
              <a:defRPr sz="1200" b="0" i="0" u="none" strike="noStrike" kern="1200" baseline="0">
                <a:solidFill>
                  <a:prstClr val="black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VEP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amplitude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 [</a:t>
            </a:r>
            <a:r>
              <a:rPr lang="de-DE" b="1" dirty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V]</a:t>
            </a:r>
          </a:p>
        </p:txBody>
      </p:sp>
      <p:sp>
        <p:nvSpPr>
          <p:cNvPr id="34" name="Textfeld 33"/>
          <p:cNvSpPr txBox="1"/>
          <p:nvPr/>
        </p:nvSpPr>
        <p:spPr>
          <a:xfrm>
            <a:off x="1807956" y="6404090"/>
            <a:ext cx="908069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Time [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s]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feld 34"/>
          <p:cNvSpPr txBox="1"/>
          <p:nvPr/>
        </p:nvSpPr>
        <p:spPr>
          <a:xfrm>
            <a:off x="1010638" y="3880673"/>
            <a:ext cx="247580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VEP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lasticity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induced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tDCS</a:t>
            </a:r>
          </a:p>
        </p:txBody>
      </p:sp>
      <p:sp>
        <p:nvSpPr>
          <p:cNvPr id="36" name="Textfeld 35"/>
          <p:cNvSpPr txBox="1"/>
          <p:nvPr/>
        </p:nvSpPr>
        <p:spPr>
          <a:xfrm>
            <a:off x="6463864" y="3692309"/>
            <a:ext cx="2284600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VEP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lasticity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induced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rolonged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visual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timulation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7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9553" y="4167051"/>
            <a:ext cx="3240424" cy="22186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38" name="Gerade Verbindung mit Pfeil 37"/>
          <p:cNvCxnSpPr/>
          <p:nvPr/>
        </p:nvCxnSpPr>
        <p:spPr>
          <a:xfrm flipV="1">
            <a:off x="1187624" y="4570672"/>
            <a:ext cx="0" cy="276998"/>
          </a:xfrm>
          <a:prstGeom prst="straightConnector1">
            <a:avLst/>
          </a:prstGeom>
          <a:ln w="25400">
            <a:solidFill>
              <a:srgbClr val="BE0028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Gerade Verbindung mit Pfeil 38"/>
          <p:cNvCxnSpPr/>
          <p:nvPr/>
        </p:nvCxnSpPr>
        <p:spPr>
          <a:xfrm>
            <a:off x="6882002" y="4556771"/>
            <a:ext cx="86885" cy="595109"/>
          </a:xfrm>
          <a:prstGeom prst="straightConnector1">
            <a:avLst/>
          </a:prstGeom>
          <a:ln w="25400">
            <a:solidFill>
              <a:srgbClr val="BE0028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Gerade Verbindung mit Pfeil 40"/>
          <p:cNvCxnSpPr/>
          <p:nvPr/>
        </p:nvCxnSpPr>
        <p:spPr>
          <a:xfrm>
            <a:off x="1475656" y="4695270"/>
            <a:ext cx="86885" cy="595109"/>
          </a:xfrm>
          <a:prstGeom prst="straightConnector1">
            <a:avLst/>
          </a:prstGeom>
          <a:ln w="25400">
            <a:solidFill>
              <a:srgbClr val="BE0028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Gerade Verbindung mit Pfeil 41"/>
          <p:cNvCxnSpPr/>
          <p:nvPr/>
        </p:nvCxnSpPr>
        <p:spPr>
          <a:xfrm flipV="1">
            <a:off x="6599432" y="4418272"/>
            <a:ext cx="0" cy="276998"/>
          </a:xfrm>
          <a:prstGeom prst="straightConnector1">
            <a:avLst/>
          </a:prstGeom>
          <a:ln w="25400">
            <a:solidFill>
              <a:srgbClr val="BE0028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Gerade Verbindung mit Pfeil 42"/>
          <p:cNvCxnSpPr/>
          <p:nvPr/>
        </p:nvCxnSpPr>
        <p:spPr>
          <a:xfrm flipV="1">
            <a:off x="1010638" y="5816627"/>
            <a:ext cx="0" cy="276998"/>
          </a:xfrm>
          <a:prstGeom prst="straightConnector1">
            <a:avLst/>
          </a:prstGeom>
          <a:ln w="25400">
            <a:solidFill>
              <a:srgbClr val="BE0028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2">
            <a:extLst>
              <a:ext uri="{FF2B5EF4-FFF2-40B4-BE49-F238E27FC236}">
                <a16:creationId xmlns="" xmlns:a16="http://schemas.microsoft.com/office/drawing/2014/main" id="{5AF0593A-006E-6244-B23D-219AD3957C88}"/>
              </a:ext>
            </a:extLst>
          </p:cNvPr>
          <p:cNvSpPr txBox="1"/>
          <p:nvPr/>
        </p:nvSpPr>
        <p:spPr>
          <a:xfrm>
            <a:off x="1199515" y="5940408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C1</a:t>
            </a:r>
          </a:p>
        </p:txBody>
      </p:sp>
      <p:sp>
        <p:nvSpPr>
          <p:cNvPr id="45" name="TextBox 24">
            <a:extLst>
              <a:ext uri="{FF2B5EF4-FFF2-40B4-BE49-F238E27FC236}">
                <a16:creationId xmlns="" xmlns:a16="http://schemas.microsoft.com/office/drawing/2014/main" id="{18E5AC81-D8FB-F548-8975-F64C7EFA1FF1}"/>
              </a:ext>
            </a:extLst>
          </p:cNvPr>
          <p:cNvSpPr txBox="1"/>
          <p:nvPr/>
        </p:nvSpPr>
        <p:spPr>
          <a:xfrm>
            <a:off x="1146880" y="4279772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P1</a:t>
            </a:r>
          </a:p>
        </p:txBody>
      </p:sp>
      <p:sp>
        <p:nvSpPr>
          <p:cNvPr id="46" name="TextBox 27">
            <a:extLst>
              <a:ext uri="{FF2B5EF4-FFF2-40B4-BE49-F238E27FC236}">
                <a16:creationId xmlns="" xmlns:a16="http://schemas.microsoft.com/office/drawing/2014/main" id="{04F83F08-2410-1F4D-849C-FA1174FCA955}"/>
              </a:ext>
            </a:extLst>
          </p:cNvPr>
          <p:cNvSpPr txBox="1"/>
          <p:nvPr/>
        </p:nvSpPr>
        <p:spPr>
          <a:xfrm>
            <a:off x="1389631" y="5459081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N1</a:t>
            </a:r>
          </a:p>
        </p:txBody>
      </p:sp>
      <p:sp>
        <p:nvSpPr>
          <p:cNvPr id="47" name="TextBox 2">
            <a:extLst>
              <a:ext uri="{FF2B5EF4-FFF2-40B4-BE49-F238E27FC236}">
                <a16:creationId xmlns="" xmlns:a16="http://schemas.microsoft.com/office/drawing/2014/main" id="{5AF0593A-006E-6244-B23D-219AD3957C88}"/>
              </a:ext>
            </a:extLst>
          </p:cNvPr>
          <p:cNvSpPr txBox="1"/>
          <p:nvPr/>
        </p:nvSpPr>
        <p:spPr>
          <a:xfrm>
            <a:off x="6424016" y="5982499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C1</a:t>
            </a:r>
          </a:p>
        </p:txBody>
      </p:sp>
      <p:sp>
        <p:nvSpPr>
          <p:cNvPr id="48" name="TextBox 24">
            <a:extLst>
              <a:ext uri="{FF2B5EF4-FFF2-40B4-BE49-F238E27FC236}">
                <a16:creationId xmlns="" xmlns:a16="http://schemas.microsoft.com/office/drawing/2014/main" id="{18E5AC81-D8FB-F548-8975-F64C7EFA1FF1}"/>
              </a:ext>
            </a:extLst>
          </p:cNvPr>
          <p:cNvSpPr txBox="1"/>
          <p:nvPr/>
        </p:nvSpPr>
        <p:spPr>
          <a:xfrm>
            <a:off x="6739335" y="4231745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P1</a:t>
            </a:r>
          </a:p>
        </p:txBody>
      </p:sp>
      <p:sp>
        <p:nvSpPr>
          <p:cNvPr id="49" name="TextBox 27">
            <a:extLst>
              <a:ext uri="{FF2B5EF4-FFF2-40B4-BE49-F238E27FC236}">
                <a16:creationId xmlns="" xmlns:a16="http://schemas.microsoft.com/office/drawing/2014/main" id="{04F83F08-2410-1F4D-849C-FA1174FCA955}"/>
              </a:ext>
            </a:extLst>
          </p:cNvPr>
          <p:cNvSpPr txBox="1"/>
          <p:nvPr/>
        </p:nvSpPr>
        <p:spPr>
          <a:xfrm>
            <a:off x="6794567" y="5465426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N1</a:t>
            </a:r>
          </a:p>
        </p:txBody>
      </p:sp>
      <p:sp>
        <p:nvSpPr>
          <p:cNvPr id="50" name="Textfeld 49"/>
          <p:cNvSpPr txBox="1"/>
          <p:nvPr/>
        </p:nvSpPr>
        <p:spPr>
          <a:xfrm>
            <a:off x="3767493" y="2113111"/>
            <a:ext cx="5453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EP</a:t>
            </a:r>
          </a:p>
        </p:txBody>
      </p:sp>
      <p:sp>
        <p:nvSpPr>
          <p:cNvPr id="51" name="Rechteck 50"/>
          <p:cNvSpPr/>
          <p:nvPr/>
        </p:nvSpPr>
        <p:spPr>
          <a:xfrm>
            <a:off x="7380312" y="854787"/>
            <a:ext cx="1694695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rolonged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b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visual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timulation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89524933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rnd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rnd" cmpd="sng" algn="ctr">
          <a:solidFill>
            <a:schemeClr val="phClr"/>
          </a:solidFill>
          <a:prstDash val="solid"/>
        </a:ln>
        <a:ln w="38100" cap="rnd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100000" t="-60000" r="100000" b="20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100000" t="100000" r="100000" b="10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1</Words>
  <Application>Microsoft Office PowerPoint</Application>
  <PresentationFormat>Bildschirmpräsentation (4:3)</PresentationFormat>
  <Paragraphs>18</Paragraphs>
  <Slides>1</Slides>
  <Notes>1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-Design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r. Lukas Frase</dc:creator>
  <cp:lastModifiedBy>Dr. Lukas Frase</cp:lastModifiedBy>
  <cp:revision>11</cp:revision>
  <dcterms:created xsi:type="dcterms:W3CDTF">2019-12-20T10:49:17Z</dcterms:created>
  <dcterms:modified xsi:type="dcterms:W3CDTF">2020-09-29T13:05:09Z</dcterms:modified>
</cp:coreProperties>
</file>